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  <p:sldMasterId id="2147483684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7" r:id="rId24"/>
    <p:sldId id="276" r:id="rId25"/>
    <p:sldId id="278" r:id="rId26"/>
    <p:sldId id="279" r:id="rId27"/>
    <p:sldId id="280" r:id="rId28"/>
    <p:sldId id="281" r:id="rId29"/>
    <p:sldId id="287" r:id="rId30"/>
    <p:sldId id="282" r:id="rId31"/>
    <p:sldId id="288" r:id="rId32"/>
  </p:sldIdLst>
  <p:sldSz cx="6227763" cy="82804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196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85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84" y="174"/>
      </p:cViewPr>
      <p:guideLst>
        <p:guide orient="horz" pos="2608"/>
        <p:guide pos="19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slide" Target="slides/slide10.xml"/><Relationship Id="rId18" Type="http://schemas.openxmlformats.org/officeDocument/2006/relationships/slide" Target="slides/slide15.xml"/><Relationship Id="rId26" Type="http://schemas.openxmlformats.org/officeDocument/2006/relationships/slide" Target="slides/slide23.xml"/><Relationship Id="rId3" Type="http://schemas.openxmlformats.org/officeDocument/2006/relationships/slideMaster" Target="slideMasters/slideMaster3.xml"/><Relationship Id="rId21" Type="http://schemas.openxmlformats.org/officeDocument/2006/relationships/slide" Target="slides/slide18.xml"/><Relationship Id="rId34" Type="http://schemas.openxmlformats.org/officeDocument/2006/relationships/viewProps" Target="viewProps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slide" Target="slides/slide14.xml"/><Relationship Id="rId25" Type="http://schemas.openxmlformats.org/officeDocument/2006/relationships/slide" Target="slides/slide22.xml"/><Relationship Id="rId33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3.xml"/><Relationship Id="rId20" Type="http://schemas.openxmlformats.org/officeDocument/2006/relationships/slide" Target="slides/slide17.xml"/><Relationship Id="rId29" Type="http://schemas.openxmlformats.org/officeDocument/2006/relationships/slide" Target="slides/slide26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24" Type="http://schemas.openxmlformats.org/officeDocument/2006/relationships/slide" Target="slides/slide21.xml"/><Relationship Id="rId32" Type="http://schemas.openxmlformats.org/officeDocument/2006/relationships/slide" Target="slides/slide29.xml"/><Relationship Id="rId5" Type="http://schemas.openxmlformats.org/officeDocument/2006/relationships/slide" Target="slides/slide2.xml"/><Relationship Id="rId15" Type="http://schemas.openxmlformats.org/officeDocument/2006/relationships/slide" Target="slides/slide12.xml"/><Relationship Id="rId23" Type="http://schemas.openxmlformats.org/officeDocument/2006/relationships/slide" Target="slides/slide20.xml"/><Relationship Id="rId28" Type="http://schemas.openxmlformats.org/officeDocument/2006/relationships/slide" Target="slides/slide25.xml"/><Relationship Id="rId36" Type="http://schemas.openxmlformats.org/officeDocument/2006/relationships/tableStyles" Target="tableStyles.xml"/><Relationship Id="rId10" Type="http://schemas.openxmlformats.org/officeDocument/2006/relationships/slide" Target="slides/slide7.xml"/><Relationship Id="rId19" Type="http://schemas.openxmlformats.org/officeDocument/2006/relationships/slide" Target="slides/slide16.xml"/><Relationship Id="rId31" Type="http://schemas.openxmlformats.org/officeDocument/2006/relationships/slide" Target="slides/slide28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slide" Target="slides/slide11.xml"/><Relationship Id="rId22" Type="http://schemas.openxmlformats.org/officeDocument/2006/relationships/slide" Target="slides/slide19.xml"/><Relationship Id="rId27" Type="http://schemas.openxmlformats.org/officeDocument/2006/relationships/slide" Target="slides/slide24.xml"/><Relationship Id="rId30" Type="http://schemas.openxmlformats.org/officeDocument/2006/relationships/slide" Target="slides/slide27.xml"/><Relationship Id="rId35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Arkusz_programu_Microsoft_Excel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Arkusz_programu_Microsoft_Excel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rkusz4!$B$5</c:f>
              <c:strCache>
                <c:ptCount val="1"/>
                <c:pt idx="0">
                  <c:v>ES655 n=10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pl-PL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(Arkusz4!$E$4,Arkusz4!$G$4)</c:f>
              <c:strCache>
                <c:ptCount val="2"/>
                <c:pt idx="0">
                  <c:v> enlarged </c:v>
                </c:pt>
                <c:pt idx="1">
                  <c:v>degenerated</c:v>
                </c:pt>
              </c:strCache>
            </c:strRef>
          </c:cat>
          <c:val>
            <c:numRef>
              <c:f>(Arkusz4!$E$5,Arkusz4!$G$5)</c:f>
              <c:numCache>
                <c:formatCode>0%</c:formatCode>
                <c:ptCount val="2"/>
                <c:pt idx="0" formatCode="0.0%">
                  <c:v>0.2</c:v>
                </c:pt>
                <c:pt idx="1">
                  <c:v>0.8</c:v>
                </c:pt>
              </c:numCache>
            </c:numRef>
          </c:val>
        </c:ser>
        <c:ser>
          <c:idx val="1"/>
          <c:order val="1"/>
          <c:tx>
            <c:strRef>
              <c:f>Arkusz4!$B$6</c:f>
              <c:strCache>
                <c:ptCount val="1"/>
                <c:pt idx="0">
                  <c:v>ES512 n=15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pl-PL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(Arkusz4!$E$4,Arkusz4!$G$4)</c:f>
              <c:strCache>
                <c:ptCount val="2"/>
                <c:pt idx="0">
                  <c:v> enlarged </c:v>
                </c:pt>
                <c:pt idx="1">
                  <c:v>degenerated</c:v>
                </c:pt>
              </c:strCache>
            </c:strRef>
          </c:cat>
          <c:val>
            <c:numRef>
              <c:f>(Arkusz4!$E$6,Arkusz4!$G$6)</c:f>
              <c:numCache>
                <c:formatCode>0%</c:formatCode>
                <c:ptCount val="2"/>
                <c:pt idx="0" formatCode="0.0%">
                  <c:v>0.66666666666666663</c:v>
                </c:pt>
                <c:pt idx="1">
                  <c:v>0.33333333333333331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363451408"/>
        <c:axId val="363451800"/>
      </c:barChart>
      <c:catAx>
        <c:axId val="3634514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>
                    <a:solidFill>
                      <a:schemeClr val="tx1"/>
                    </a:solidFill>
                  </a:rPr>
                  <a:t>types of pistils on the 7 DAE</a:t>
                </a:r>
              </a:p>
            </c:rich>
          </c:tx>
          <c:layout>
            <c:manualLayout>
              <c:xMode val="edge"/>
              <c:yMode val="edge"/>
              <c:x val="0.30206854577960357"/>
              <c:y val="0.786124403477450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363451800"/>
        <c:crosses val="autoZero"/>
        <c:auto val="1"/>
        <c:lblAlgn val="ctr"/>
        <c:lblOffset val="100"/>
        <c:noMultiLvlLbl val="0"/>
      </c:catAx>
      <c:valAx>
        <c:axId val="3634518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>
                    <a:solidFill>
                      <a:schemeClr val="tx1"/>
                    </a:solidFill>
                  </a:rPr>
                  <a:t>unpollinated pisti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363451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3540644375974733E-2"/>
          <c:y val="0.88948533579367683"/>
          <c:w val="0.65980257936507936"/>
          <c:h val="9.664406532516767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rkusz4!$J$14</c:f>
              <c:strCache>
                <c:ptCount val="1"/>
                <c:pt idx="0">
                  <c:v>ES655 n=159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2"/>
              <c:layout>
                <c:manualLayout>
                  <c:x val="-2.0607937398603268E-2"/>
                  <c:y val="3.1897918623135135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layout>
                <c:manualLayout>
                  <c:x val="-2.4729524878324072E-2"/>
                  <c:y val="3.1897918623135135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pl-PL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rkusz4!$M$13:$P$13</c:f>
              <c:strCache>
                <c:ptCount val="4"/>
                <c:pt idx="0">
                  <c:v>intact egg/cc</c:v>
                </c:pt>
                <c:pt idx="1">
                  <c:v>FG deg</c:v>
                </c:pt>
                <c:pt idx="2">
                  <c:v> zls/els</c:v>
                </c:pt>
                <c:pt idx="3">
                  <c:v>AE</c:v>
                </c:pt>
              </c:strCache>
            </c:strRef>
          </c:cat>
          <c:val>
            <c:numRef>
              <c:f>Arkusz4!$M$14:$P$14</c:f>
              <c:numCache>
                <c:formatCode>0.0%</c:formatCode>
                <c:ptCount val="4"/>
                <c:pt idx="0">
                  <c:v>0.76100628930817615</c:v>
                </c:pt>
                <c:pt idx="1">
                  <c:v>0.2389937106918239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"/>
          <c:order val="1"/>
          <c:tx>
            <c:strRef>
              <c:f>Arkusz4!$J$15</c:f>
              <c:strCache>
                <c:ptCount val="1"/>
                <c:pt idx="0">
                  <c:v>ES512 n=807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2.0607937398603268E-2"/>
                  <c:y val="0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pl-PL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rkusz4!$M$13:$P$13</c:f>
              <c:strCache>
                <c:ptCount val="4"/>
                <c:pt idx="0">
                  <c:v>intact egg/cc</c:v>
                </c:pt>
                <c:pt idx="1">
                  <c:v>FG deg</c:v>
                </c:pt>
                <c:pt idx="2">
                  <c:v> zls/els</c:v>
                </c:pt>
                <c:pt idx="3">
                  <c:v>AE</c:v>
                </c:pt>
              </c:strCache>
            </c:strRef>
          </c:cat>
          <c:val>
            <c:numRef>
              <c:f>Arkusz4!$M$15:$P$15</c:f>
              <c:numCache>
                <c:formatCode>0.0%</c:formatCode>
                <c:ptCount val="4"/>
                <c:pt idx="0">
                  <c:v>0.63197026022304836</c:v>
                </c:pt>
                <c:pt idx="1">
                  <c:v>0.35439900867410162</c:v>
                </c:pt>
                <c:pt idx="2">
                  <c:v>1.2391573729863693E-2</c:v>
                </c:pt>
                <c:pt idx="3">
                  <c:v>1.2391573729863693E-3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363453368"/>
        <c:axId val="363452584"/>
      </c:barChart>
      <c:catAx>
        <c:axId val="3634533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>
                    <a:solidFill>
                      <a:schemeClr val="tx1"/>
                    </a:solidFill>
                  </a:rPr>
                  <a:t>types of unfertilized</a:t>
                </a:r>
                <a:r>
                  <a:rPr lang="pl-PL" baseline="0">
                    <a:solidFill>
                      <a:schemeClr val="tx1"/>
                    </a:solidFill>
                  </a:rPr>
                  <a:t> ovules on the 7DAE</a:t>
                </a:r>
                <a:endParaRPr lang="pl-PL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24175309050325339"/>
              <c:y val="0.904518319375641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363452584"/>
        <c:crosses val="autoZero"/>
        <c:auto val="1"/>
        <c:lblAlgn val="ctr"/>
        <c:lblOffset val="100"/>
        <c:noMultiLvlLbl val="0"/>
      </c:catAx>
      <c:valAx>
        <c:axId val="3634525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>
                    <a:solidFill>
                      <a:schemeClr val="tx1"/>
                    </a:solidFill>
                  </a:rPr>
                  <a:t>unfertilized ovul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3634533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9899062028657613"/>
          <c:y val="4.4681449049605276E-2"/>
          <c:w val="0.33860820841168887"/>
          <c:h val="0.171202221504499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7082" y="1355149"/>
            <a:ext cx="5293599" cy="2882806"/>
          </a:xfrm>
        </p:spPr>
        <p:txBody>
          <a:bodyPr anchor="b"/>
          <a:lstStyle>
            <a:lvl1pPr algn="ctr">
              <a:defRPr sz="4087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8471" y="4349128"/>
            <a:ext cx="4670822" cy="1999179"/>
          </a:xfrm>
        </p:spPr>
        <p:txBody>
          <a:bodyPr/>
          <a:lstStyle>
            <a:lvl1pPr marL="0" indent="0" algn="ctr">
              <a:buNone/>
              <a:defRPr sz="1635"/>
            </a:lvl1pPr>
            <a:lvl2pPr marL="311399" indent="0" algn="ctr">
              <a:buNone/>
              <a:defRPr sz="1362"/>
            </a:lvl2pPr>
            <a:lvl3pPr marL="622798" indent="0" algn="ctr">
              <a:buNone/>
              <a:defRPr sz="1226"/>
            </a:lvl3pPr>
            <a:lvl4pPr marL="934197" indent="0" algn="ctr">
              <a:buNone/>
              <a:defRPr sz="1090"/>
            </a:lvl4pPr>
            <a:lvl5pPr marL="1245596" indent="0" algn="ctr">
              <a:buNone/>
              <a:defRPr sz="1090"/>
            </a:lvl5pPr>
            <a:lvl6pPr marL="1556995" indent="0" algn="ctr">
              <a:buNone/>
              <a:defRPr sz="1090"/>
            </a:lvl6pPr>
            <a:lvl7pPr marL="1868394" indent="0" algn="ctr">
              <a:buNone/>
              <a:defRPr sz="1090"/>
            </a:lvl7pPr>
            <a:lvl8pPr marL="2179792" indent="0" algn="ctr">
              <a:buNone/>
              <a:defRPr sz="1090"/>
            </a:lvl8pPr>
            <a:lvl9pPr marL="2491191" indent="0" algn="ctr">
              <a:buNone/>
              <a:defRPr sz="1090"/>
            </a:lvl9pPr>
          </a:lstStyle>
          <a:p>
            <a:r>
              <a:rPr lang="pl-PL" smtClean="0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182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849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56743" y="440855"/>
            <a:ext cx="1342861" cy="7017256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8159" y="440855"/>
            <a:ext cx="3950737" cy="7017256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45758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7082" y="1355150"/>
            <a:ext cx="5293599" cy="2882806"/>
          </a:xfrm>
        </p:spPr>
        <p:txBody>
          <a:bodyPr anchor="b"/>
          <a:lstStyle>
            <a:lvl1pPr algn="ctr">
              <a:defRPr sz="3762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8471" y="4349128"/>
            <a:ext cx="4670822" cy="1999179"/>
          </a:xfrm>
        </p:spPr>
        <p:txBody>
          <a:bodyPr/>
          <a:lstStyle>
            <a:lvl1pPr marL="0" indent="0" algn="ctr">
              <a:buNone/>
              <a:defRPr sz="1505"/>
            </a:lvl1pPr>
            <a:lvl2pPr marL="286630" indent="0" algn="ctr">
              <a:buNone/>
              <a:defRPr sz="1254"/>
            </a:lvl2pPr>
            <a:lvl3pPr marL="573260" indent="0" algn="ctr">
              <a:buNone/>
              <a:defRPr sz="1128"/>
            </a:lvl3pPr>
            <a:lvl4pPr marL="859890" indent="0" algn="ctr">
              <a:buNone/>
              <a:defRPr sz="1003"/>
            </a:lvl4pPr>
            <a:lvl5pPr marL="1146520" indent="0" algn="ctr">
              <a:buNone/>
              <a:defRPr sz="1003"/>
            </a:lvl5pPr>
            <a:lvl6pPr marL="1433151" indent="0" algn="ctr">
              <a:buNone/>
              <a:defRPr sz="1003"/>
            </a:lvl6pPr>
            <a:lvl7pPr marL="1719781" indent="0" algn="ctr">
              <a:buNone/>
              <a:defRPr sz="1003"/>
            </a:lvl7pPr>
            <a:lvl8pPr marL="2006411" indent="0" algn="ctr">
              <a:buNone/>
              <a:defRPr sz="1003"/>
            </a:lvl8pPr>
            <a:lvl9pPr marL="2293041" indent="0" algn="ctr">
              <a:buNone/>
              <a:defRPr sz="1003"/>
            </a:lvl9pPr>
          </a:lstStyle>
          <a:p>
            <a:r>
              <a:rPr lang="pl-PL" smtClean="0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4236693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668362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916" y="2064352"/>
            <a:ext cx="5371446" cy="3444416"/>
          </a:xfrm>
        </p:spPr>
        <p:txBody>
          <a:bodyPr anchor="b"/>
          <a:lstStyle>
            <a:lvl1pPr>
              <a:defRPr sz="3762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916" y="5541353"/>
            <a:ext cx="5371446" cy="1811337"/>
          </a:xfrm>
        </p:spPr>
        <p:txBody>
          <a:bodyPr/>
          <a:lstStyle>
            <a:lvl1pPr marL="0" indent="0">
              <a:buNone/>
              <a:defRPr sz="1505">
                <a:solidFill>
                  <a:schemeClr val="tx1"/>
                </a:solidFill>
              </a:defRPr>
            </a:lvl1pPr>
            <a:lvl2pPr marL="286630" indent="0">
              <a:buNone/>
              <a:defRPr sz="1254">
                <a:solidFill>
                  <a:schemeClr val="tx1">
                    <a:tint val="75000"/>
                  </a:schemeClr>
                </a:solidFill>
              </a:defRPr>
            </a:lvl2pPr>
            <a:lvl3pPr marL="573260" indent="0">
              <a:buNone/>
              <a:defRPr sz="1128">
                <a:solidFill>
                  <a:schemeClr val="tx1">
                    <a:tint val="75000"/>
                  </a:schemeClr>
                </a:solidFill>
              </a:defRPr>
            </a:lvl3pPr>
            <a:lvl4pPr marL="859890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4pPr>
            <a:lvl5pPr marL="1146520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5pPr>
            <a:lvl6pPr marL="1433151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6pPr>
            <a:lvl7pPr marL="1719781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7pPr>
            <a:lvl8pPr marL="2006411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8pPr>
            <a:lvl9pPr marL="2293041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551603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8159" y="2204273"/>
            <a:ext cx="2646799" cy="52538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52806" y="2204273"/>
            <a:ext cx="2646799" cy="52538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786138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440857"/>
            <a:ext cx="5371446" cy="1600494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971" y="2029850"/>
            <a:ext cx="2634635" cy="994797"/>
          </a:xfrm>
        </p:spPr>
        <p:txBody>
          <a:bodyPr anchor="b"/>
          <a:lstStyle>
            <a:lvl1pPr marL="0" indent="0">
              <a:buNone/>
              <a:defRPr sz="1505" b="1"/>
            </a:lvl1pPr>
            <a:lvl2pPr marL="286630" indent="0">
              <a:buNone/>
              <a:defRPr sz="1254" b="1"/>
            </a:lvl2pPr>
            <a:lvl3pPr marL="573260" indent="0">
              <a:buNone/>
              <a:defRPr sz="1128" b="1"/>
            </a:lvl3pPr>
            <a:lvl4pPr marL="859890" indent="0">
              <a:buNone/>
              <a:defRPr sz="1003" b="1"/>
            </a:lvl4pPr>
            <a:lvl5pPr marL="1146520" indent="0">
              <a:buNone/>
              <a:defRPr sz="1003" b="1"/>
            </a:lvl5pPr>
            <a:lvl6pPr marL="1433151" indent="0">
              <a:buNone/>
              <a:defRPr sz="1003" b="1"/>
            </a:lvl6pPr>
            <a:lvl7pPr marL="1719781" indent="0">
              <a:buNone/>
              <a:defRPr sz="1003" b="1"/>
            </a:lvl7pPr>
            <a:lvl8pPr marL="2006411" indent="0">
              <a:buNone/>
              <a:defRPr sz="1003" b="1"/>
            </a:lvl8pPr>
            <a:lvl9pPr marL="2293041" indent="0">
              <a:buNone/>
              <a:defRPr sz="1003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971" y="3024647"/>
            <a:ext cx="2634635" cy="4448799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52806" y="2029850"/>
            <a:ext cx="2647610" cy="994797"/>
          </a:xfrm>
        </p:spPr>
        <p:txBody>
          <a:bodyPr anchor="b"/>
          <a:lstStyle>
            <a:lvl1pPr marL="0" indent="0">
              <a:buNone/>
              <a:defRPr sz="1505" b="1"/>
            </a:lvl1pPr>
            <a:lvl2pPr marL="286630" indent="0">
              <a:buNone/>
              <a:defRPr sz="1254" b="1"/>
            </a:lvl2pPr>
            <a:lvl3pPr marL="573260" indent="0">
              <a:buNone/>
              <a:defRPr sz="1128" b="1"/>
            </a:lvl3pPr>
            <a:lvl4pPr marL="859890" indent="0">
              <a:buNone/>
              <a:defRPr sz="1003" b="1"/>
            </a:lvl4pPr>
            <a:lvl5pPr marL="1146520" indent="0">
              <a:buNone/>
              <a:defRPr sz="1003" b="1"/>
            </a:lvl5pPr>
            <a:lvl6pPr marL="1433151" indent="0">
              <a:buNone/>
              <a:defRPr sz="1003" b="1"/>
            </a:lvl6pPr>
            <a:lvl7pPr marL="1719781" indent="0">
              <a:buNone/>
              <a:defRPr sz="1003" b="1"/>
            </a:lvl7pPr>
            <a:lvl8pPr marL="2006411" indent="0">
              <a:buNone/>
              <a:defRPr sz="1003" b="1"/>
            </a:lvl8pPr>
            <a:lvl9pPr marL="2293041" indent="0">
              <a:buNone/>
              <a:defRPr sz="1003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52806" y="3024647"/>
            <a:ext cx="2647610" cy="4448799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074170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5319106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889294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7"/>
            <a:ext cx="2008616" cy="1932093"/>
          </a:xfrm>
        </p:spPr>
        <p:txBody>
          <a:bodyPr anchor="b"/>
          <a:lstStyle>
            <a:lvl1pPr>
              <a:defRPr sz="2006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7611" y="1192227"/>
            <a:ext cx="3152805" cy="5884451"/>
          </a:xfrm>
        </p:spPr>
        <p:txBody>
          <a:bodyPr/>
          <a:lstStyle>
            <a:lvl1pPr>
              <a:defRPr sz="2006"/>
            </a:lvl1pPr>
            <a:lvl2pPr>
              <a:defRPr sz="1755"/>
            </a:lvl2pPr>
            <a:lvl3pPr>
              <a:defRPr sz="1505"/>
            </a:lvl3pPr>
            <a:lvl4pPr>
              <a:defRPr sz="1254"/>
            </a:lvl4pPr>
            <a:lvl5pPr>
              <a:defRPr sz="1254"/>
            </a:lvl5pPr>
            <a:lvl6pPr>
              <a:defRPr sz="1254"/>
            </a:lvl6pPr>
            <a:lvl7pPr>
              <a:defRPr sz="1254"/>
            </a:lvl7pPr>
            <a:lvl8pPr>
              <a:defRPr sz="1254"/>
            </a:lvl8pPr>
            <a:lvl9pPr>
              <a:defRPr sz="1254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1"/>
            <a:ext cx="2008616" cy="4602139"/>
          </a:xfrm>
        </p:spPr>
        <p:txBody>
          <a:bodyPr/>
          <a:lstStyle>
            <a:lvl1pPr marL="0" indent="0">
              <a:buNone/>
              <a:defRPr sz="1003"/>
            </a:lvl1pPr>
            <a:lvl2pPr marL="286630" indent="0">
              <a:buNone/>
              <a:defRPr sz="878"/>
            </a:lvl2pPr>
            <a:lvl3pPr marL="573260" indent="0">
              <a:buNone/>
              <a:defRPr sz="752"/>
            </a:lvl3pPr>
            <a:lvl4pPr marL="859890" indent="0">
              <a:buNone/>
              <a:defRPr sz="627"/>
            </a:lvl4pPr>
            <a:lvl5pPr marL="1146520" indent="0">
              <a:buNone/>
              <a:defRPr sz="627"/>
            </a:lvl5pPr>
            <a:lvl6pPr marL="1433151" indent="0">
              <a:buNone/>
              <a:defRPr sz="627"/>
            </a:lvl6pPr>
            <a:lvl7pPr marL="1719781" indent="0">
              <a:buNone/>
              <a:defRPr sz="627"/>
            </a:lvl7pPr>
            <a:lvl8pPr marL="2006411" indent="0">
              <a:buNone/>
              <a:defRPr sz="627"/>
            </a:lvl8pPr>
            <a:lvl9pPr marL="2293041" indent="0">
              <a:buNone/>
              <a:defRPr sz="627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58092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69609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7"/>
            <a:ext cx="2008616" cy="1932093"/>
          </a:xfrm>
        </p:spPr>
        <p:txBody>
          <a:bodyPr anchor="b"/>
          <a:lstStyle>
            <a:lvl1pPr>
              <a:defRPr sz="2006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7611" y="1192227"/>
            <a:ext cx="3152805" cy="5884451"/>
          </a:xfrm>
        </p:spPr>
        <p:txBody>
          <a:bodyPr anchor="t"/>
          <a:lstStyle>
            <a:lvl1pPr marL="0" indent="0">
              <a:buNone/>
              <a:defRPr sz="2006"/>
            </a:lvl1pPr>
            <a:lvl2pPr marL="286630" indent="0">
              <a:buNone/>
              <a:defRPr sz="1755"/>
            </a:lvl2pPr>
            <a:lvl3pPr marL="573260" indent="0">
              <a:buNone/>
              <a:defRPr sz="1505"/>
            </a:lvl3pPr>
            <a:lvl4pPr marL="859890" indent="0">
              <a:buNone/>
              <a:defRPr sz="1254"/>
            </a:lvl4pPr>
            <a:lvl5pPr marL="1146520" indent="0">
              <a:buNone/>
              <a:defRPr sz="1254"/>
            </a:lvl5pPr>
            <a:lvl6pPr marL="1433151" indent="0">
              <a:buNone/>
              <a:defRPr sz="1254"/>
            </a:lvl6pPr>
            <a:lvl7pPr marL="1719781" indent="0">
              <a:buNone/>
              <a:defRPr sz="1254"/>
            </a:lvl7pPr>
            <a:lvl8pPr marL="2006411" indent="0">
              <a:buNone/>
              <a:defRPr sz="1254"/>
            </a:lvl8pPr>
            <a:lvl9pPr marL="2293041" indent="0">
              <a:buNone/>
              <a:defRPr sz="1254"/>
            </a:lvl9pPr>
          </a:lstStyle>
          <a:p>
            <a:r>
              <a:rPr lang="pl-PL" smtClean="0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1"/>
            <a:ext cx="2008616" cy="4602139"/>
          </a:xfrm>
        </p:spPr>
        <p:txBody>
          <a:bodyPr/>
          <a:lstStyle>
            <a:lvl1pPr marL="0" indent="0">
              <a:buNone/>
              <a:defRPr sz="1003"/>
            </a:lvl1pPr>
            <a:lvl2pPr marL="286630" indent="0">
              <a:buNone/>
              <a:defRPr sz="878"/>
            </a:lvl2pPr>
            <a:lvl3pPr marL="573260" indent="0">
              <a:buNone/>
              <a:defRPr sz="752"/>
            </a:lvl3pPr>
            <a:lvl4pPr marL="859890" indent="0">
              <a:buNone/>
              <a:defRPr sz="627"/>
            </a:lvl4pPr>
            <a:lvl5pPr marL="1146520" indent="0">
              <a:buNone/>
              <a:defRPr sz="627"/>
            </a:lvl5pPr>
            <a:lvl6pPr marL="1433151" indent="0">
              <a:buNone/>
              <a:defRPr sz="627"/>
            </a:lvl6pPr>
            <a:lvl7pPr marL="1719781" indent="0">
              <a:buNone/>
              <a:defRPr sz="627"/>
            </a:lvl7pPr>
            <a:lvl8pPr marL="2006411" indent="0">
              <a:buNone/>
              <a:defRPr sz="627"/>
            </a:lvl8pPr>
            <a:lvl9pPr marL="2293041" indent="0">
              <a:buNone/>
              <a:defRPr sz="627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987510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0508782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56744" y="440855"/>
            <a:ext cx="1342861" cy="7017256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8159" y="440855"/>
            <a:ext cx="3950737" cy="7017256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6258316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7083" y="1355150"/>
            <a:ext cx="5293599" cy="2882807"/>
          </a:xfrm>
        </p:spPr>
        <p:txBody>
          <a:bodyPr anchor="b"/>
          <a:lstStyle>
            <a:lvl1pPr algn="ctr">
              <a:defRPr sz="3779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8471" y="4349127"/>
            <a:ext cx="4670822" cy="1999179"/>
          </a:xfrm>
        </p:spPr>
        <p:txBody>
          <a:bodyPr/>
          <a:lstStyle>
            <a:lvl1pPr marL="0" indent="0" algn="ctr">
              <a:buNone/>
              <a:defRPr sz="1512"/>
            </a:lvl1pPr>
            <a:lvl2pPr marL="287960" indent="0" algn="ctr">
              <a:buNone/>
              <a:defRPr sz="1261"/>
            </a:lvl2pPr>
            <a:lvl3pPr marL="575923" indent="0" algn="ctr">
              <a:buNone/>
              <a:defRPr sz="1134"/>
            </a:lvl3pPr>
            <a:lvl4pPr marL="863885" indent="0" algn="ctr">
              <a:buNone/>
              <a:defRPr sz="1008"/>
            </a:lvl4pPr>
            <a:lvl5pPr marL="1151846" indent="0" algn="ctr">
              <a:buNone/>
              <a:defRPr sz="1008"/>
            </a:lvl5pPr>
            <a:lvl6pPr marL="1439807" indent="0" algn="ctr">
              <a:buNone/>
              <a:defRPr sz="1008"/>
            </a:lvl6pPr>
            <a:lvl7pPr marL="1727768" indent="0" algn="ctr">
              <a:buNone/>
              <a:defRPr sz="1008"/>
            </a:lvl7pPr>
            <a:lvl8pPr marL="2015731" indent="0" algn="ctr">
              <a:buNone/>
              <a:defRPr sz="1008"/>
            </a:lvl8pPr>
            <a:lvl9pPr marL="2303692" indent="0" algn="ctr">
              <a:buNone/>
              <a:defRPr sz="1008"/>
            </a:lvl9pPr>
          </a:lstStyle>
          <a:p>
            <a:r>
              <a:rPr lang="pl-PL" smtClean="0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6236564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5476586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915" y="2064353"/>
            <a:ext cx="5371446" cy="3444415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915" y="5541352"/>
            <a:ext cx="5371446" cy="1811338"/>
          </a:xfrm>
        </p:spPr>
        <p:txBody>
          <a:bodyPr/>
          <a:lstStyle>
            <a:lvl1pPr marL="0" indent="0">
              <a:buNone/>
              <a:defRPr sz="1512">
                <a:solidFill>
                  <a:schemeClr val="tx1"/>
                </a:solidFill>
              </a:defRPr>
            </a:lvl1pPr>
            <a:lvl2pPr marL="287960" indent="0">
              <a:buNone/>
              <a:defRPr sz="1261">
                <a:solidFill>
                  <a:schemeClr val="tx1">
                    <a:tint val="75000"/>
                  </a:schemeClr>
                </a:solidFill>
              </a:defRPr>
            </a:lvl2pPr>
            <a:lvl3pPr marL="5759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3pPr>
            <a:lvl4pPr marL="863885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4pPr>
            <a:lvl5pPr marL="1151846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5pPr>
            <a:lvl6pPr marL="1439807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6pPr>
            <a:lvl7pPr marL="1727768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7pPr>
            <a:lvl8pPr marL="201573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8pPr>
            <a:lvl9pPr marL="230369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35482363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8166" y="2204281"/>
            <a:ext cx="2646799" cy="52538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52812" y="2204281"/>
            <a:ext cx="2646799" cy="52538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67699507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440863"/>
            <a:ext cx="5371446" cy="1600495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972" y="2029848"/>
            <a:ext cx="2634635" cy="994797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60" indent="0">
              <a:buNone/>
              <a:defRPr sz="1261" b="1"/>
            </a:lvl2pPr>
            <a:lvl3pPr marL="575923" indent="0">
              <a:buNone/>
              <a:defRPr sz="1134" b="1"/>
            </a:lvl3pPr>
            <a:lvl4pPr marL="863885" indent="0">
              <a:buNone/>
              <a:defRPr sz="1008" b="1"/>
            </a:lvl4pPr>
            <a:lvl5pPr marL="1151846" indent="0">
              <a:buNone/>
              <a:defRPr sz="1008" b="1"/>
            </a:lvl5pPr>
            <a:lvl6pPr marL="1439807" indent="0">
              <a:buNone/>
              <a:defRPr sz="1008" b="1"/>
            </a:lvl6pPr>
            <a:lvl7pPr marL="1727768" indent="0">
              <a:buNone/>
              <a:defRPr sz="1008" b="1"/>
            </a:lvl7pPr>
            <a:lvl8pPr marL="2015731" indent="0">
              <a:buNone/>
              <a:defRPr sz="1008" b="1"/>
            </a:lvl8pPr>
            <a:lvl9pPr marL="2303692" indent="0">
              <a:buNone/>
              <a:defRPr sz="1008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972" y="3024652"/>
            <a:ext cx="2634635" cy="4448799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52806" y="2029848"/>
            <a:ext cx="2647610" cy="994797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60" indent="0">
              <a:buNone/>
              <a:defRPr sz="1261" b="1"/>
            </a:lvl2pPr>
            <a:lvl3pPr marL="575923" indent="0">
              <a:buNone/>
              <a:defRPr sz="1134" b="1"/>
            </a:lvl3pPr>
            <a:lvl4pPr marL="863885" indent="0">
              <a:buNone/>
              <a:defRPr sz="1008" b="1"/>
            </a:lvl4pPr>
            <a:lvl5pPr marL="1151846" indent="0">
              <a:buNone/>
              <a:defRPr sz="1008" b="1"/>
            </a:lvl5pPr>
            <a:lvl6pPr marL="1439807" indent="0">
              <a:buNone/>
              <a:defRPr sz="1008" b="1"/>
            </a:lvl6pPr>
            <a:lvl7pPr marL="1727768" indent="0">
              <a:buNone/>
              <a:defRPr sz="1008" b="1"/>
            </a:lvl7pPr>
            <a:lvl8pPr marL="2015731" indent="0">
              <a:buNone/>
              <a:defRPr sz="1008" b="1"/>
            </a:lvl8pPr>
            <a:lvl9pPr marL="2303692" indent="0">
              <a:buNone/>
              <a:defRPr sz="1008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52806" y="3024652"/>
            <a:ext cx="2647610" cy="4448799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3401903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1763355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82652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915" y="2064352"/>
            <a:ext cx="5371446" cy="3444416"/>
          </a:xfrm>
        </p:spPr>
        <p:txBody>
          <a:bodyPr anchor="b"/>
          <a:lstStyle>
            <a:lvl1pPr>
              <a:defRPr sz="4087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915" y="5541353"/>
            <a:ext cx="5371446" cy="1811337"/>
          </a:xfrm>
        </p:spPr>
        <p:txBody>
          <a:bodyPr/>
          <a:lstStyle>
            <a:lvl1pPr marL="0" indent="0">
              <a:buNone/>
              <a:defRPr sz="1635">
                <a:solidFill>
                  <a:schemeClr val="tx1"/>
                </a:solidFill>
              </a:defRPr>
            </a:lvl1pPr>
            <a:lvl2pPr marL="311399" indent="0">
              <a:buNone/>
              <a:defRPr sz="1362">
                <a:solidFill>
                  <a:schemeClr val="tx1">
                    <a:tint val="75000"/>
                  </a:schemeClr>
                </a:solidFill>
              </a:defRPr>
            </a:lvl2pPr>
            <a:lvl3pPr marL="622798" indent="0">
              <a:buNone/>
              <a:defRPr sz="1226">
                <a:solidFill>
                  <a:schemeClr val="tx1">
                    <a:tint val="75000"/>
                  </a:schemeClr>
                </a:solidFill>
              </a:defRPr>
            </a:lvl3pPr>
            <a:lvl4pPr marL="934197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4pPr>
            <a:lvl5pPr marL="1245596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5pPr>
            <a:lvl6pPr marL="1556995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6pPr>
            <a:lvl7pPr marL="1868394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7pPr>
            <a:lvl8pPr marL="2179792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8pPr>
            <a:lvl9pPr marL="2491191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853823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5"/>
            <a:ext cx="2008616" cy="1932094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7617" y="1192233"/>
            <a:ext cx="3152805" cy="5884451"/>
          </a:xfrm>
        </p:spPr>
        <p:txBody>
          <a:bodyPr/>
          <a:lstStyle>
            <a:lvl1pPr>
              <a:defRPr sz="2016"/>
            </a:lvl1pPr>
            <a:lvl2pPr>
              <a:defRPr sz="1764"/>
            </a:lvl2pPr>
            <a:lvl3pPr>
              <a:defRPr sz="1512"/>
            </a:lvl3pPr>
            <a:lvl4pPr>
              <a:defRPr sz="1261"/>
            </a:lvl4pPr>
            <a:lvl5pPr>
              <a:defRPr sz="1261"/>
            </a:lvl5pPr>
            <a:lvl6pPr>
              <a:defRPr sz="1261"/>
            </a:lvl6pPr>
            <a:lvl7pPr>
              <a:defRPr sz="1261"/>
            </a:lvl7pPr>
            <a:lvl8pPr>
              <a:defRPr sz="1261"/>
            </a:lvl8pPr>
            <a:lvl9pPr>
              <a:defRPr sz="1261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8"/>
            <a:ext cx="2008616" cy="4602139"/>
          </a:xfrm>
        </p:spPr>
        <p:txBody>
          <a:bodyPr/>
          <a:lstStyle>
            <a:lvl1pPr marL="0" indent="0">
              <a:buNone/>
              <a:defRPr sz="1008"/>
            </a:lvl1pPr>
            <a:lvl2pPr marL="287960" indent="0">
              <a:buNone/>
              <a:defRPr sz="882"/>
            </a:lvl2pPr>
            <a:lvl3pPr marL="575923" indent="0">
              <a:buNone/>
              <a:defRPr sz="757"/>
            </a:lvl3pPr>
            <a:lvl4pPr marL="863885" indent="0">
              <a:buNone/>
              <a:defRPr sz="630"/>
            </a:lvl4pPr>
            <a:lvl5pPr marL="1151846" indent="0">
              <a:buNone/>
              <a:defRPr sz="630"/>
            </a:lvl5pPr>
            <a:lvl6pPr marL="1439807" indent="0">
              <a:buNone/>
              <a:defRPr sz="630"/>
            </a:lvl6pPr>
            <a:lvl7pPr marL="1727768" indent="0">
              <a:buNone/>
              <a:defRPr sz="630"/>
            </a:lvl7pPr>
            <a:lvl8pPr marL="2015731" indent="0">
              <a:buNone/>
              <a:defRPr sz="630"/>
            </a:lvl8pPr>
            <a:lvl9pPr marL="2303692" indent="0">
              <a:buNone/>
              <a:defRPr sz="63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3878383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5"/>
            <a:ext cx="2008616" cy="1932094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7617" y="1192233"/>
            <a:ext cx="3152805" cy="5884451"/>
          </a:xfrm>
        </p:spPr>
        <p:txBody>
          <a:bodyPr anchor="t"/>
          <a:lstStyle>
            <a:lvl1pPr marL="0" indent="0">
              <a:buNone/>
              <a:defRPr sz="2016"/>
            </a:lvl1pPr>
            <a:lvl2pPr marL="287960" indent="0">
              <a:buNone/>
              <a:defRPr sz="1764"/>
            </a:lvl2pPr>
            <a:lvl3pPr marL="575923" indent="0">
              <a:buNone/>
              <a:defRPr sz="1512"/>
            </a:lvl3pPr>
            <a:lvl4pPr marL="863885" indent="0">
              <a:buNone/>
              <a:defRPr sz="1261"/>
            </a:lvl4pPr>
            <a:lvl5pPr marL="1151846" indent="0">
              <a:buNone/>
              <a:defRPr sz="1261"/>
            </a:lvl5pPr>
            <a:lvl6pPr marL="1439807" indent="0">
              <a:buNone/>
              <a:defRPr sz="1261"/>
            </a:lvl6pPr>
            <a:lvl7pPr marL="1727768" indent="0">
              <a:buNone/>
              <a:defRPr sz="1261"/>
            </a:lvl7pPr>
            <a:lvl8pPr marL="2015731" indent="0">
              <a:buNone/>
              <a:defRPr sz="1261"/>
            </a:lvl8pPr>
            <a:lvl9pPr marL="2303692" indent="0">
              <a:buNone/>
              <a:defRPr sz="1261"/>
            </a:lvl9pPr>
          </a:lstStyle>
          <a:p>
            <a:r>
              <a:rPr lang="pl-PL" smtClean="0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8"/>
            <a:ext cx="2008616" cy="4602139"/>
          </a:xfrm>
        </p:spPr>
        <p:txBody>
          <a:bodyPr/>
          <a:lstStyle>
            <a:lvl1pPr marL="0" indent="0">
              <a:buNone/>
              <a:defRPr sz="1008"/>
            </a:lvl1pPr>
            <a:lvl2pPr marL="287960" indent="0">
              <a:buNone/>
              <a:defRPr sz="882"/>
            </a:lvl2pPr>
            <a:lvl3pPr marL="575923" indent="0">
              <a:buNone/>
              <a:defRPr sz="757"/>
            </a:lvl3pPr>
            <a:lvl4pPr marL="863885" indent="0">
              <a:buNone/>
              <a:defRPr sz="630"/>
            </a:lvl4pPr>
            <a:lvl5pPr marL="1151846" indent="0">
              <a:buNone/>
              <a:defRPr sz="630"/>
            </a:lvl5pPr>
            <a:lvl6pPr marL="1439807" indent="0">
              <a:buNone/>
              <a:defRPr sz="630"/>
            </a:lvl6pPr>
            <a:lvl7pPr marL="1727768" indent="0">
              <a:buNone/>
              <a:defRPr sz="630"/>
            </a:lvl7pPr>
            <a:lvl8pPr marL="2015731" indent="0">
              <a:buNone/>
              <a:defRPr sz="630"/>
            </a:lvl8pPr>
            <a:lvl9pPr marL="2303692" indent="0">
              <a:buNone/>
              <a:defRPr sz="63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0792035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123793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56750" y="440859"/>
            <a:ext cx="1342861" cy="7017256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8166" y="440859"/>
            <a:ext cx="3950737" cy="7017256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59607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8159" y="2204273"/>
            <a:ext cx="2646799" cy="52538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52805" y="2204273"/>
            <a:ext cx="2646799" cy="52538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836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440856"/>
            <a:ext cx="5371446" cy="1600495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971" y="2029849"/>
            <a:ext cx="2634635" cy="994797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971" y="3024646"/>
            <a:ext cx="2634635" cy="4448799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52806" y="2029849"/>
            <a:ext cx="2647610" cy="994797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52806" y="3024646"/>
            <a:ext cx="2647610" cy="4448799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084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436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444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7"/>
            <a:ext cx="2008616" cy="1932093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7610" y="1192226"/>
            <a:ext cx="3152805" cy="5884451"/>
          </a:xfrm>
        </p:spPr>
        <p:txBody>
          <a:bodyPr/>
          <a:lstStyle>
            <a:lvl1pPr>
              <a:defRPr sz="2180"/>
            </a:lvl1pPr>
            <a:lvl2pPr>
              <a:defRPr sz="1907"/>
            </a:lvl2pPr>
            <a:lvl3pPr>
              <a:defRPr sz="1635"/>
            </a:lvl3pPr>
            <a:lvl4pPr>
              <a:defRPr sz="1362"/>
            </a:lvl4pPr>
            <a:lvl5pPr>
              <a:defRPr sz="1362"/>
            </a:lvl5pPr>
            <a:lvl6pPr>
              <a:defRPr sz="1362"/>
            </a:lvl6pPr>
            <a:lvl7pPr>
              <a:defRPr sz="1362"/>
            </a:lvl7pPr>
            <a:lvl8pPr>
              <a:defRPr sz="1362"/>
            </a:lvl8pPr>
            <a:lvl9pPr>
              <a:defRPr sz="1362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0"/>
            <a:ext cx="2008616" cy="4602140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887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7"/>
            <a:ext cx="2008616" cy="1932093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7610" y="1192226"/>
            <a:ext cx="3152805" cy="5884451"/>
          </a:xfrm>
        </p:spPr>
        <p:txBody>
          <a:bodyPr anchor="t"/>
          <a:lstStyle>
            <a:lvl1pPr marL="0" indent="0">
              <a:buNone/>
              <a:defRPr sz="2180"/>
            </a:lvl1pPr>
            <a:lvl2pPr marL="311399" indent="0">
              <a:buNone/>
              <a:defRPr sz="1907"/>
            </a:lvl2pPr>
            <a:lvl3pPr marL="622798" indent="0">
              <a:buNone/>
              <a:defRPr sz="1635"/>
            </a:lvl3pPr>
            <a:lvl4pPr marL="934197" indent="0">
              <a:buNone/>
              <a:defRPr sz="1362"/>
            </a:lvl4pPr>
            <a:lvl5pPr marL="1245596" indent="0">
              <a:buNone/>
              <a:defRPr sz="1362"/>
            </a:lvl5pPr>
            <a:lvl6pPr marL="1556995" indent="0">
              <a:buNone/>
              <a:defRPr sz="1362"/>
            </a:lvl6pPr>
            <a:lvl7pPr marL="1868394" indent="0">
              <a:buNone/>
              <a:defRPr sz="1362"/>
            </a:lvl7pPr>
            <a:lvl8pPr marL="2179792" indent="0">
              <a:buNone/>
              <a:defRPr sz="1362"/>
            </a:lvl8pPr>
            <a:lvl9pPr marL="2491191" indent="0">
              <a:buNone/>
              <a:defRPr sz="1362"/>
            </a:lvl9pPr>
          </a:lstStyle>
          <a:p>
            <a:r>
              <a:rPr lang="pl-PL" smtClean="0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0"/>
            <a:ext cx="2008616" cy="4602140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960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8159" y="440856"/>
            <a:ext cx="5371446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159" y="2204273"/>
            <a:ext cx="5371446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8159" y="7674706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00DE9-9216-4945-AA3E-32129678083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62947" y="7674706"/>
            <a:ext cx="210187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8357" y="7674706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806BB-95BE-4413-89E2-EEBFF1E3D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065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2798" rtl="0" eaLnBrk="1" latinLnBrk="0" hangingPunct="1">
        <a:lnSpc>
          <a:spcPct val="90000"/>
        </a:lnSpc>
        <a:spcBef>
          <a:spcPct val="0"/>
        </a:spcBef>
        <a:buNone/>
        <a:defRPr sz="29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699" indent="-155699" algn="l" defTabSz="622798" rtl="0" eaLnBrk="1" latinLnBrk="0" hangingPunct="1">
        <a:lnSpc>
          <a:spcPct val="90000"/>
        </a:lnSpc>
        <a:spcBef>
          <a:spcPts val="681"/>
        </a:spcBef>
        <a:buFont typeface="Arial" panose="020B0604020202020204" pitchFamily="34" charset="0"/>
        <a:buChar char="•"/>
        <a:defRPr sz="1907" kern="1200">
          <a:solidFill>
            <a:schemeClr val="tx1"/>
          </a:solidFill>
          <a:latin typeface="+mn-lt"/>
          <a:ea typeface="+mn-ea"/>
          <a:cs typeface="+mn-cs"/>
        </a:defRPr>
      </a:lvl1pPr>
      <a:lvl2pPr marL="467098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635" kern="1200">
          <a:solidFill>
            <a:schemeClr val="tx1"/>
          </a:solidFill>
          <a:latin typeface="+mn-lt"/>
          <a:ea typeface="+mn-ea"/>
          <a:cs typeface="+mn-cs"/>
        </a:defRPr>
      </a:lvl2pPr>
      <a:lvl3pPr marL="778497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362" kern="1200">
          <a:solidFill>
            <a:schemeClr val="tx1"/>
          </a:solidFill>
          <a:latin typeface="+mn-lt"/>
          <a:ea typeface="+mn-ea"/>
          <a:cs typeface="+mn-cs"/>
        </a:defRPr>
      </a:lvl3pPr>
      <a:lvl4pPr marL="1089896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401295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712694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2024093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335492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646891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1pPr>
      <a:lvl2pPr marL="311399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2pPr>
      <a:lvl3pPr marL="622798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3pPr>
      <a:lvl4pPr marL="934197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245596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556995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1868394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179792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491191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8159" y="440857"/>
            <a:ext cx="5371446" cy="16004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159" y="2204273"/>
            <a:ext cx="5371446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8159" y="7674707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282AA-BFC9-4EF5-908C-1401CD1F031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05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62947" y="7674707"/>
            <a:ext cx="210187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8358" y="7674707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1DE9F-8E22-40D6-A9B0-C63C5A20B95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0870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73260" rtl="0" eaLnBrk="1" latinLnBrk="0" hangingPunct="1">
        <a:lnSpc>
          <a:spcPct val="90000"/>
        </a:lnSpc>
        <a:spcBef>
          <a:spcPct val="0"/>
        </a:spcBef>
        <a:buNone/>
        <a:defRPr sz="27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315" indent="-143315" algn="l" defTabSz="573260" rtl="0" eaLnBrk="1" latinLnBrk="0" hangingPunct="1">
        <a:lnSpc>
          <a:spcPct val="90000"/>
        </a:lnSpc>
        <a:spcBef>
          <a:spcPts val="627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1pPr>
      <a:lvl2pPr marL="429945" indent="-143315" algn="l" defTabSz="573260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505" kern="1200">
          <a:solidFill>
            <a:schemeClr val="tx1"/>
          </a:solidFill>
          <a:latin typeface="+mn-lt"/>
          <a:ea typeface="+mn-ea"/>
          <a:cs typeface="+mn-cs"/>
        </a:defRPr>
      </a:lvl2pPr>
      <a:lvl3pPr marL="716575" indent="-143315" algn="l" defTabSz="573260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254" kern="1200">
          <a:solidFill>
            <a:schemeClr val="tx1"/>
          </a:solidFill>
          <a:latin typeface="+mn-lt"/>
          <a:ea typeface="+mn-ea"/>
          <a:cs typeface="+mn-cs"/>
        </a:defRPr>
      </a:lvl3pPr>
      <a:lvl4pPr marL="1003205" indent="-143315" algn="l" defTabSz="573260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4pPr>
      <a:lvl5pPr marL="1289835" indent="-143315" algn="l" defTabSz="573260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5pPr>
      <a:lvl6pPr marL="1576466" indent="-143315" algn="l" defTabSz="573260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6pPr>
      <a:lvl7pPr marL="1863096" indent="-143315" algn="l" defTabSz="573260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7pPr>
      <a:lvl8pPr marL="2149726" indent="-143315" algn="l" defTabSz="573260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8pPr>
      <a:lvl9pPr marL="2436356" indent="-143315" algn="l" defTabSz="573260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3260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1pPr>
      <a:lvl2pPr marL="286630" algn="l" defTabSz="573260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2pPr>
      <a:lvl3pPr marL="573260" algn="l" defTabSz="573260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3pPr>
      <a:lvl4pPr marL="859890" algn="l" defTabSz="573260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4pPr>
      <a:lvl5pPr marL="1146520" algn="l" defTabSz="573260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5pPr>
      <a:lvl6pPr marL="1433151" algn="l" defTabSz="573260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6pPr>
      <a:lvl7pPr marL="1719781" algn="l" defTabSz="573260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7pPr>
      <a:lvl8pPr marL="2006411" algn="l" defTabSz="573260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8pPr>
      <a:lvl9pPr marL="2293041" algn="l" defTabSz="573260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8159" y="440863"/>
            <a:ext cx="5371446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159" y="2204281"/>
            <a:ext cx="5371446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8166" y="7674711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06212"/>
            <a:fld id="{F4FC3B89-20D5-466E-800C-3E6C59E33F02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506212"/>
              <a:t>5/9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62947" y="7674711"/>
            <a:ext cx="210187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06212"/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8364" y="7674711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06212"/>
            <a:fld id="{FB3481C8-ECCD-4699-9F09-A93937DE98E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506212"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82331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75923" rtl="0" eaLnBrk="1" latinLnBrk="0" hangingPunct="1">
        <a:lnSpc>
          <a:spcPct val="90000"/>
        </a:lnSpc>
        <a:spcBef>
          <a:spcPct val="0"/>
        </a:spcBef>
        <a:buNone/>
        <a:defRPr sz="27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981" indent="-143981" algn="l" defTabSz="575923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1pPr>
      <a:lvl2pPr marL="431943" indent="-143981" algn="l" defTabSz="575923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19905" indent="-143981" algn="l" defTabSz="575923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261" kern="1200">
          <a:solidFill>
            <a:schemeClr val="tx1"/>
          </a:solidFill>
          <a:latin typeface="+mn-lt"/>
          <a:ea typeface="+mn-ea"/>
          <a:cs typeface="+mn-cs"/>
        </a:defRPr>
      </a:lvl3pPr>
      <a:lvl4pPr marL="1007865" indent="-143981" algn="l" defTabSz="575923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295828" indent="-143981" algn="l" defTabSz="575923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583789" indent="-143981" algn="l" defTabSz="575923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871751" indent="-143981" algn="l" defTabSz="575923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159711" indent="-143981" algn="l" defTabSz="575923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447672" indent="-143981" algn="l" defTabSz="575923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5923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1pPr>
      <a:lvl2pPr marL="287960" algn="l" defTabSz="575923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75923" algn="l" defTabSz="575923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3pPr>
      <a:lvl4pPr marL="863885" algn="l" defTabSz="575923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151846" algn="l" defTabSz="575923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439807" algn="l" defTabSz="575923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727768" algn="l" defTabSz="575923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015731" algn="l" defTabSz="575923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303692" algn="l" defTabSz="575923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85" y="23323"/>
            <a:ext cx="6184392" cy="5910072"/>
          </a:xfrm>
          <a:prstGeom prst="rect">
            <a:avLst/>
          </a:prstGeom>
        </p:spPr>
      </p:pic>
      <p:sp>
        <p:nvSpPr>
          <p:cNvPr id="5" name="Prostokąt 4"/>
          <p:cNvSpPr/>
          <p:nvPr/>
        </p:nvSpPr>
        <p:spPr>
          <a:xfrm>
            <a:off x="481572" y="6220476"/>
            <a:ext cx="500482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henotype of tested plant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TM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S655 and ES512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60580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793" y="22324"/>
            <a:ext cx="6227763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6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ability of seeds evaluated by TTC test.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contrast to all viable seeds of LTM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, F, I),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S655 and ES512 contained mixture of seeds that were viable (red-staining; the examples marked by black arrow) or non-viable (yellow-milky staining; the examples marked by white arrow). ES512 siliques usually contain a few or more undeveloped seeds (arrowheads)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559420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3" y="0"/>
            <a:ext cx="6227763" cy="6400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10241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0" y="0"/>
            <a:ext cx="6227763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7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tubulin-cytoskeleton pictures of early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gasporogenesi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ages. Nuclei are shown in blue (DAPI staining), microtubules are shown in red (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yLight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™ 549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vules of ES655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MC at differentiation from 2-celled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chespor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reticular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tubu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ytoskeleton within the cell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-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iocyt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 prophase I; microtubule distributed uniformly within the cell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-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iocyt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ES512 at prophase I. Rich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tubu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ytoskeleton of MMC occurs throughout the cytoplasm in random orientation as well as associated with the enlarged nucleus area. Arrowhead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ndicates a nucleus of the parietal or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el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.</a:t>
            </a:r>
            <a:endParaRPr lang="pl-PL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: arch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chespor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; mmc - megaspore mother cell; pc - parietal cell. Bar = 10 µm corresponds to all images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374183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36" y="0"/>
            <a:ext cx="6076890" cy="828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439049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0" y="0"/>
            <a:ext cx="6227763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8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riability in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los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rrangement during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gasporogenesi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los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as detected via aniline blue staining (yellow). Nomenclature of each meiotic stages corresponds to Fig. 3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MC stage. Different patterns of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los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stribution in ES512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iocyt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on one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the both tips of MMC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round MMC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irregularly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-H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 dyad stage. Dyads with cells that were unequal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almost equal in size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The lack of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los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dyad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hat existed in the late-stage ovule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-K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riad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-P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trads.</a:t>
            </a:r>
            <a:endParaRPr lang="pl-PL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: arch –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chespor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; ii - inner integument; oi – outer integument; mmc – megaspore mother cell; pc - parietal cell. The MMC and following cells are outlined by a thin dashed line (on the right). Merged or separated: DIC (differential interference contrast microscopy) images and DAB (decolorized aniline blue) detection. Bar = 10 µm corresponds to all images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130687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501" y="6030"/>
            <a:ext cx="4556760" cy="7278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056293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0" y="0"/>
            <a:ext cx="6227763" cy="5262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9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tubulin-cytoskeleton pictures around fertilization and embryogenesis. Nuclei are shown in blue (DAPI staining), microtubules are red (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yLight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™ 549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S 512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mature FG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FG during fertilization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igd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re enriched in longitudinal microtubules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while the egg cell contains a hooplike cortical system of MTs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MTs surrounding nuclear envelope of CCN at fertilization seems to be denser and brighter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-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 few-celled embryo and early nuclear endosperm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rotubules cortically arranged in the embryo-proper and forming mitotic spindle in the suspensor cell. The RMSs surrounding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y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laz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endosperm nuclei (arrowheads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-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late-globular embryo stage in ES655 seed. MTs cortically arranged in embryo cells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forming RMSs in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y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entral endosperm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dense microtubule network in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laz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yst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endParaRPr lang="pl-PL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FG - female gametophyte; MTs – microtubules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embryo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ucleus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c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egg cell nucleus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c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 central cell nucleus; RMS - radial microtubule system; ME –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y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ndosperm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laz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yst; s - suspensor. Bar = 10 µm corresponds to all photographs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217799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33" y="0"/>
            <a:ext cx="6150896" cy="828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112239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-1" y="13436"/>
            <a:ext cx="6227763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0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lectron micrographs of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gagametogenesi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ES655 line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-nucleate embryo sac; the cytoplasm is rich in one or two-lobular mitochondria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ellu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generation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y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le of 7-celled FG; FG is surrounded by well-developed integumentary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petu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pet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contain plastids with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stoglobul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starch; cell connections via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smodesmat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owhead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, E-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many mitochondria and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ctyosom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re visible in contrast to sporadically occurring the starch-free plastids. The filiform apparatus of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d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 strongly expanded. </a:t>
            </a:r>
            <a:endParaRPr lang="pl-PL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N- nucleus; Nu- nucleolus; M- mitochondria; D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ctyosom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P- plastids; RER- rough endoplasmic reticulum; V- vacuole; W- cell wall; FA- filiform apparatus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ellu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it- integumentary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petu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575484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33" y="0"/>
            <a:ext cx="6150896" cy="828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7131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429" y="16256"/>
            <a:ext cx="4946904" cy="8247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770372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-1" y="20625"/>
            <a:ext cx="6227763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1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lectron micrographs of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gagametogenesi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ES512 line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-nucleate FG. Ovule tissues contain many lipids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plastids that accumulate starch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the cytoplasm of the FG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s rich in mitochondria, plastids and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ctyosom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smodesmat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etween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el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(arrowheads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-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ture FG. A thin layer of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ellu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 still present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are completely developed with many mitochondria, RER,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ctyosom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vesicles and plastids that accumulate starch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tensive wall ingrowth at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y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le formed the filiform apparatus;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smodesmat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nnection (arrows) are present between the adjacent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. </a:t>
            </a:r>
            <a:endParaRPr lang="pl-PL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N- nucleus; Nu- nucleolus; M- mitochondria; D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ctyosom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P- plastids; RER- rough endoplasmic reticulum; L- lipids; V- vacuole; W- cell wall; Wi- wall ingrowth; FA- filiform apparatus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ellu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it- integumentary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petu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407305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85" y="0"/>
            <a:ext cx="6103393" cy="828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797227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0" y="0"/>
            <a:ext cx="6207162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2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llen development in </a:t>
            </a:r>
            <a:r>
              <a:rPr lang="en-GB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GB" sz="1200" i="1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ict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GB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655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left column), ES512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-H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iddle column) and LTM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-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right column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B, D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sporocytes surrounded by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los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t meiotic prophase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, E, G, 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rospore tetrads surrounded by thick layer of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los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, H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- or 2-nucleate microspores / pollen grains from anthers of small and mid-size flower buds. 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-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d-size flower bud of containing mostly 2-nucleate pollen grain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arge flower bud of ES655 line containing mainly 3-nucleate pollen grains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petu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sappeared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iable pollen grains (arrows) or degenerated pollen (arrowheads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-nucleate pollen grains with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los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yellow) around the generative cell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ure pollen of LTM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-W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rphology of pollen from open flower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API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, G, 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rged DIC (differential interference contrast microscopy) images and DAPI (blue) staining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ouble staining by DAPI and DAB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,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, F, H-I, L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C;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C + DAB (decolorized aniline blue)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J-K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mi-thin sections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raffin section. Bar = 10 µm in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picture corresponds to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-P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-W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hotographs. 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825289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93" y="26109"/>
            <a:ext cx="6208776" cy="7668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903765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-1" y="0"/>
            <a:ext cx="6227763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3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mbryogenesis in the LTM line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 the time of fertilization. The sperm nucleus adheres to the egg cell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generation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-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age of the zygote and free nuclear endosperm. Mitotic division of endosperm nuclei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shead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 undivided zygote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endosperm advanced in the development by forming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laz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yst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Young globular embryo with a few-celled suspensor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eart stage of the embryo; endosperm divided into three regions: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ularize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y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gion, peripheral region where the nuclei are situated parietal and around the central vacuole, and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laz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gion where the nuclei together with cytoplasm formed a cyst. </a:t>
            </a:r>
            <a:endParaRPr lang="pl-PL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i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sperm nucleus; z- zygote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c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central cell nucleus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embryo; s- suspensor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laz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yst; ME-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y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ndosperm; PE- peripheral endosperm CZE –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laz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ndosperm. A clearing material visualized by DIC. Bar = 10 µm in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corresponds to (a-e) images. 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342782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33" y="0"/>
            <a:ext cx="6150896" cy="828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470840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-1" y="31383"/>
            <a:ext cx="6227763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4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lectron micrographs of embryogenesis in ES655 line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C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ge of 2-4 celled embryo development; part of suspensor cell and free-nuclear endosperm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 of suspensor is highly vacuolated and mostly contains spherical or elongated plastids near the nucleus. The cytoplasm of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y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laz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endosperm is rich in SER, mitochondria and many plastids having well-developed thylakoid structures and including stromal thylakoids and grana stacks, and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stoglobul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rrowheads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-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ndosperm at late heart-stage embryo development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lazal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ndosperm is nuclear with few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tochnodri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thylakoids-filled plastid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ular endosperm at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ylar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le consists of vacuolated cells, which are one or two nucleate and accumulate starch in plastids (arrows).</a:t>
            </a:r>
            <a:endParaRPr lang="pl-PL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: P-plastid, V-vacuole, SER- smooth endoplasmic reticulum, N-nucleus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endosperm;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suspensor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656279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upa 35"/>
          <p:cNvGrpSpPr/>
          <p:nvPr/>
        </p:nvGrpSpPr>
        <p:grpSpPr>
          <a:xfrm>
            <a:off x="404398" y="402108"/>
            <a:ext cx="5127735" cy="2424757"/>
            <a:chOff x="404398" y="240183"/>
            <a:chExt cx="5127735" cy="2424757"/>
          </a:xfrm>
        </p:grpSpPr>
        <p:grpSp>
          <p:nvGrpSpPr>
            <p:cNvPr id="34" name="Grupa 33"/>
            <p:cNvGrpSpPr/>
            <p:nvPr/>
          </p:nvGrpSpPr>
          <p:grpSpPr>
            <a:xfrm>
              <a:off x="404398" y="240183"/>
              <a:ext cx="2364529" cy="2404606"/>
              <a:chOff x="417909" y="821657"/>
              <a:chExt cx="2364529" cy="2404606"/>
            </a:xfrm>
          </p:grpSpPr>
          <p:grpSp>
            <p:nvGrpSpPr>
              <p:cNvPr id="24" name="Grupa 23"/>
              <p:cNvGrpSpPr/>
              <p:nvPr/>
            </p:nvGrpSpPr>
            <p:grpSpPr>
              <a:xfrm>
                <a:off x="417909" y="821657"/>
                <a:ext cx="2364529" cy="2404606"/>
                <a:chOff x="417909" y="821657"/>
                <a:chExt cx="2364529" cy="2404606"/>
              </a:xfrm>
            </p:grpSpPr>
            <p:pic>
              <p:nvPicPr>
                <p:cNvPr id="7" name="Obraz 6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3691"/>
                <a:stretch/>
              </p:blipFill>
              <p:spPr>
                <a:xfrm>
                  <a:off x="417909" y="821657"/>
                  <a:ext cx="2364529" cy="2404606"/>
                </a:xfrm>
                <a:prstGeom prst="rect">
                  <a:avLst/>
                </a:prstGeom>
              </p:spPr>
            </p:pic>
            <p:sp>
              <p:nvSpPr>
                <p:cNvPr id="3" name="Prostokąt 2"/>
                <p:cNvSpPr/>
                <p:nvPr/>
              </p:nvSpPr>
              <p:spPr>
                <a:xfrm>
                  <a:off x="1419367" y="908786"/>
                  <a:ext cx="380883" cy="16696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prstClr val="white"/>
                    </a:solidFill>
                  </a:endParaRPr>
                </a:p>
              </p:txBody>
            </p:sp>
          </p:grpSp>
          <p:sp>
            <p:nvSpPr>
              <p:cNvPr id="11" name="pole tekstowe 10"/>
              <p:cNvSpPr txBox="1"/>
              <p:nvPr/>
            </p:nvSpPr>
            <p:spPr>
              <a:xfrm>
                <a:off x="715583" y="1066187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400" dirty="0">
                    <a:solidFill>
                      <a:prstClr val="black"/>
                    </a:solidFill>
                  </a:rPr>
                  <a:t>A</a:t>
                </a:r>
                <a:endParaRPr lang="en-US" sz="14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2" name="pole tekstowe 1"/>
              <p:cNvSpPr txBox="1"/>
              <p:nvPr/>
            </p:nvSpPr>
            <p:spPr>
              <a:xfrm>
                <a:off x="2363750" y="1129170"/>
                <a:ext cx="393056" cy="2337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19" dirty="0">
                    <a:solidFill>
                      <a:prstClr val="black"/>
                    </a:solidFill>
                  </a:rPr>
                  <a:t>LTM</a:t>
                </a:r>
                <a:endParaRPr lang="en-US" sz="919" dirty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35" name="Grupa 34"/>
            <p:cNvGrpSpPr/>
            <p:nvPr/>
          </p:nvGrpSpPr>
          <p:grpSpPr>
            <a:xfrm>
              <a:off x="3167604" y="286915"/>
              <a:ext cx="2364529" cy="2378025"/>
              <a:chOff x="3162353" y="854889"/>
              <a:chExt cx="2364529" cy="2378025"/>
            </a:xfrm>
          </p:grpSpPr>
          <p:grpSp>
            <p:nvGrpSpPr>
              <p:cNvPr id="26" name="Grupa 25"/>
              <p:cNvGrpSpPr/>
              <p:nvPr/>
            </p:nvGrpSpPr>
            <p:grpSpPr>
              <a:xfrm>
                <a:off x="3162353" y="854889"/>
                <a:ext cx="2364529" cy="2378025"/>
                <a:chOff x="3162353" y="854889"/>
                <a:chExt cx="2364529" cy="2378025"/>
              </a:xfrm>
            </p:grpSpPr>
            <p:pic>
              <p:nvPicPr>
                <p:cNvPr id="8" name="Obraz 7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54203"/>
                <a:stretch/>
              </p:blipFill>
              <p:spPr>
                <a:xfrm>
                  <a:off x="3162353" y="854889"/>
                  <a:ext cx="2364529" cy="2378025"/>
                </a:xfrm>
                <a:prstGeom prst="rect">
                  <a:avLst/>
                </a:prstGeom>
              </p:spPr>
            </p:pic>
            <p:sp>
              <p:nvSpPr>
                <p:cNvPr id="23" name="Prostokąt 22"/>
                <p:cNvSpPr/>
                <p:nvPr/>
              </p:nvSpPr>
              <p:spPr>
                <a:xfrm>
                  <a:off x="4142679" y="908786"/>
                  <a:ext cx="380883" cy="16696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prstClr val="white"/>
                    </a:solidFill>
                  </a:endParaRPr>
                </a:p>
              </p:txBody>
            </p:sp>
          </p:grpSp>
          <p:sp>
            <p:nvSpPr>
              <p:cNvPr id="13" name="pole tekstowe 12"/>
              <p:cNvSpPr txBox="1"/>
              <p:nvPr/>
            </p:nvSpPr>
            <p:spPr>
              <a:xfrm>
                <a:off x="3448616" y="1075754"/>
                <a:ext cx="28245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400" dirty="0">
                    <a:solidFill>
                      <a:prstClr val="black"/>
                    </a:solidFill>
                  </a:rPr>
                  <a:t>B</a:t>
                </a:r>
                <a:endParaRPr lang="en-US" sz="14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8" name="pole tekstowe 17"/>
              <p:cNvSpPr txBox="1"/>
              <p:nvPr/>
            </p:nvSpPr>
            <p:spPr>
              <a:xfrm>
                <a:off x="5087237" y="1127220"/>
                <a:ext cx="393056" cy="2337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19" dirty="0">
                    <a:solidFill>
                      <a:prstClr val="black"/>
                    </a:solidFill>
                  </a:rPr>
                  <a:t>LTM</a:t>
                </a:r>
                <a:endParaRPr lang="en-US" sz="919" dirty="0">
                  <a:solidFill>
                    <a:prstClr val="black"/>
                  </a:solidFill>
                </a:endParaRPr>
              </a:p>
            </p:txBody>
          </p:sp>
        </p:grpSp>
      </p:grpSp>
      <p:grpSp>
        <p:nvGrpSpPr>
          <p:cNvPr id="42" name="Grupa 41"/>
          <p:cNvGrpSpPr/>
          <p:nvPr/>
        </p:nvGrpSpPr>
        <p:grpSpPr>
          <a:xfrm>
            <a:off x="402240" y="5427466"/>
            <a:ext cx="5135049" cy="2441310"/>
            <a:chOff x="402240" y="5427466"/>
            <a:chExt cx="5135049" cy="2441310"/>
          </a:xfrm>
        </p:grpSpPr>
        <p:grpSp>
          <p:nvGrpSpPr>
            <p:cNvPr id="40" name="Grupa 39"/>
            <p:cNvGrpSpPr/>
            <p:nvPr/>
          </p:nvGrpSpPr>
          <p:grpSpPr>
            <a:xfrm>
              <a:off x="402240" y="5477110"/>
              <a:ext cx="2457217" cy="2391666"/>
              <a:chOff x="402240" y="5477110"/>
              <a:chExt cx="2457217" cy="2391666"/>
            </a:xfrm>
          </p:grpSpPr>
          <p:grpSp>
            <p:nvGrpSpPr>
              <p:cNvPr id="31" name="Grupa 30"/>
              <p:cNvGrpSpPr/>
              <p:nvPr/>
            </p:nvGrpSpPr>
            <p:grpSpPr>
              <a:xfrm>
                <a:off x="402240" y="5477110"/>
                <a:ext cx="2457217" cy="2391666"/>
                <a:chOff x="441722" y="5707994"/>
                <a:chExt cx="2457217" cy="2391666"/>
              </a:xfrm>
            </p:grpSpPr>
            <p:pic>
              <p:nvPicPr>
                <p:cNvPr id="5" name="Obraz 4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54305"/>
                <a:stretch/>
              </p:blipFill>
              <p:spPr>
                <a:xfrm>
                  <a:off x="441722" y="5707994"/>
                  <a:ext cx="2457217" cy="2391666"/>
                </a:xfrm>
                <a:prstGeom prst="rect">
                  <a:avLst/>
                </a:prstGeom>
              </p:spPr>
            </p:pic>
            <p:sp>
              <p:nvSpPr>
                <p:cNvPr id="30" name="Prostokąt 29"/>
                <p:cNvSpPr/>
                <p:nvPr/>
              </p:nvSpPr>
              <p:spPr>
                <a:xfrm>
                  <a:off x="1479888" y="5766245"/>
                  <a:ext cx="380883" cy="16696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prstClr val="white"/>
                    </a:solidFill>
                  </a:endParaRPr>
                </a:p>
              </p:txBody>
            </p:sp>
          </p:grpSp>
          <p:sp>
            <p:nvSpPr>
              <p:cNvPr id="16" name="pole tekstowe 15"/>
              <p:cNvSpPr txBox="1"/>
              <p:nvPr/>
            </p:nvSpPr>
            <p:spPr>
              <a:xfrm>
                <a:off x="702959" y="5702938"/>
                <a:ext cx="24311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400" dirty="0">
                    <a:solidFill>
                      <a:prstClr val="black"/>
                    </a:solidFill>
                  </a:rPr>
                  <a:t>E</a:t>
                </a:r>
                <a:endParaRPr lang="en-US" sz="14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21" name="pole tekstowe 20"/>
              <p:cNvSpPr txBox="1"/>
              <p:nvPr/>
            </p:nvSpPr>
            <p:spPr>
              <a:xfrm>
                <a:off x="2277846" y="5748162"/>
                <a:ext cx="474810" cy="2337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19" dirty="0">
                    <a:solidFill>
                      <a:prstClr val="black"/>
                    </a:solidFill>
                  </a:rPr>
                  <a:t>ES512</a:t>
                </a:r>
                <a:endParaRPr lang="en-US" sz="919" dirty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41" name="Grupa 40"/>
            <p:cNvGrpSpPr/>
            <p:nvPr/>
          </p:nvGrpSpPr>
          <p:grpSpPr>
            <a:xfrm>
              <a:off x="3080072" y="5427466"/>
              <a:ext cx="2457217" cy="2412993"/>
              <a:chOff x="3080072" y="5427466"/>
              <a:chExt cx="2457217" cy="2412993"/>
            </a:xfrm>
          </p:grpSpPr>
          <p:grpSp>
            <p:nvGrpSpPr>
              <p:cNvPr id="32" name="Grupa 31"/>
              <p:cNvGrpSpPr/>
              <p:nvPr/>
            </p:nvGrpSpPr>
            <p:grpSpPr>
              <a:xfrm>
                <a:off x="3080072" y="5427466"/>
                <a:ext cx="2457217" cy="2412993"/>
                <a:chOff x="3104513" y="5668421"/>
                <a:chExt cx="2457217" cy="2412993"/>
              </a:xfrm>
            </p:grpSpPr>
            <p:pic>
              <p:nvPicPr>
                <p:cNvPr id="10" name="Obraz 9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3897"/>
                <a:stretch/>
              </p:blipFill>
              <p:spPr>
                <a:xfrm>
                  <a:off x="3104513" y="5668421"/>
                  <a:ext cx="2457217" cy="2412993"/>
                </a:xfrm>
                <a:prstGeom prst="rect">
                  <a:avLst/>
                </a:prstGeom>
              </p:spPr>
            </p:pic>
            <p:sp>
              <p:nvSpPr>
                <p:cNvPr id="29" name="Prostokąt 28"/>
                <p:cNvSpPr/>
                <p:nvPr/>
              </p:nvSpPr>
              <p:spPr>
                <a:xfrm>
                  <a:off x="4184219" y="5766245"/>
                  <a:ext cx="380883" cy="16696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prstClr val="white"/>
                    </a:solidFill>
                  </a:endParaRPr>
                </a:p>
              </p:txBody>
            </p:sp>
          </p:grpSp>
          <p:sp>
            <p:nvSpPr>
              <p:cNvPr id="17" name="pole tekstowe 16"/>
              <p:cNvSpPr txBox="1"/>
              <p:nvPr/>
            </p:nvSpPr>
            <p:spPr>
              <a:xfrm>
                <a:off x="3444847" y="5692258"/>
                <a:ext cx="24311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400">
                    <a:solidFill>
                      <a:prstClr val="black"/>
                    </a:solidFill>
                  </a:rPr>
                  <a:t>F</a:t>
                </a:r>
                <a:endParaRPr lang="en-US" sz="14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22" name="pole tekstowe 21"/>
              <p:cNvSpPr txBox="1"/>
              <p:nvPr/>
            </p:nvSpPr>
            <p:spPr>
              <a:xfrm>
                <a:off x="5035953" y="5742624"/>
                <a:ext cx="474810" cy="2337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19" dirty="0">
                    <a:solidFill>
                      <a:prstClr val="black"/>
                    </a:solidFill>
                  </a:rPr>
                  <a:t>ES512</a:t>
                </a:r>
                <a:endParaRPr lang="en-US" sz="919" dirty="0">
                  <a:solidFill>
                    <a:prstClr val="black"/>
                  </a:solidFill>
                </a:endParaRPr>
              </a:p>
            </p:txBody>
          </p:sp>
        </p:grpSp>
      </p:grpSp>
      <p:grpSp>
        <p:nvGrpSpPr>
          <p:cNvPr id="39" name="Grupa 38"/>
          <p:cNvGrpSpPr/>
          <p:nvPr/>
        </p:nvGrpSpPr>
        <p:grpSpPr>
          <a:xfrm>
            <a:off x="383632" y="2887688"/>
            <a:ext cx="5166250" cy="2443690"/>
            <a:chOff x="383632" y="2887688"/>
            <a:chExt cx="5166250" cy="2443690"/>
          </a:xfrm>
        </p:grpSpPr>
        <p:grpSp>
          <p:nvGrpSpPr>
            <p:cNvPr id="38" name="Grupa 37"/>
            <p:cNvGrpSpPr/>
            <p:nvPr/>
          </p:nvGrpSpPr>
          <p:grpSpPr>
            <a:xfrm>
              <a:off x="3167604" y="2887688"/>
              <a:ext cx="2382278" cy="2420776"/>
              <a:chOff x="3167604" y="2887688"/>
              <a:chExt cx="2382278" cy="2420776"/>
            </a:xfrm>
          </p:grpSpPr>
          <p:grpSp>
            <p:nvGrpSpPr>
              <p:cNvPr id="33" name="Grupa 32"/>
              <p:cNvGrpSpPr/>
              <p:nvPr/>
            </p:nvGrpSpPr>
            <p:grpSpPr>
              <a:xfrm>
                <a:off x="3167604" y="2887688"/>
                <a:ext cx="2382278" cy="2420776"/>
                <a:chOff x="3183522" y="3259495"/>
                <a:chExt cx="2382278" cy="2420776"/>
              </a:xfrm>
            </p:grpSpPr>
            <p:pic>
              <p:nvPicPr>
                <p:cNvPr id="6" name="Obraz 5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4333"/>
                <a:stretch/>
              </p:blipFill>
              <p:spPr>
                <a:xfrm>
                  <a:off x="3183522" y="3259495"/>
                  <a:ext cx="2382278" cy="2420776"/>
                </a:xfrm>
                <a:prstGeom prst="rect">
                  <a:avLst/>
                </a:prstGeom>
              </p:spPr>
            </p:pic>
            <p:sp>
              <p:nvSpPr>
                <p:cNvPr id="27" name="Prostokąt 26"/>
                <p:cNvSpPr/>
                <p:nvPr/>
              </p:nvSpPr>
              <p:spPr>
                <a:xfrm>
                  <a:off x="4142678" y="3369021"/>
                  <a:ext cx="380883" cy="16696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prstClr val="white"/>
                    </a:solidFill>
                  </a:endParaRPr>
                </a:p>
              </p:txBody>
            </p:sp>
          </p:grpSp>
          <p:sp>
            <p:nvSpPr>
              <p:cNvPr id="14" name="pole tekstowe 13"/>
              <p:cNvSpPr txBox="1"/>
              <p:nvPr/>
            </p:nvSpPr>
            <p:spPr>
              <a:xfrm>
                <a:off x="3433153" y="3144728"/>
                <a:ext cx="24311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400" dirty="0">
                    <a:solidFill>
                      <a:prstClr val="black"/>
                    </a:solidFill>
                  </a:rPr>
                  <a:t>D</a:t>
                </a:r>
                <a:endParaRPr lang="en-US" sz="14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20" name="pole tekstowe 19"/>
              <p:cNvSpPr txBox="1"/>
              <p:nvPr/>
            </p:nvSpPr>
            <p:spPr>
              <a:xfrm>
                <a:off x="5046360" y="3203575"/>
                <a:ext cx="474810" cy="2337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19" dirty="0">
                    <a:solidFill>
                      <a:prstClr val="black"/>
                    </a:solidFill>
                  </a:rPr>
                  <a:t>ES655</a:t>
                </a:r>
                <a:endParaRPr lang="en-US" sz="919" dirty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37" name="Grupa 36"/>
            <p:cNvGrpSpPr/>
            <p:nvPr/>
          </p:nvGrpSpPr>
          <p:grpSpPr>
            <a:xfrm>
              <a:off x="383632" y="2952446"/>
              <a:ext cx="2382278" cy="2378932"/>
              <a:chOff x="383632" y="2952446"/>
              <a:chExt cx="2382278" cy="2378932"/>
            </a:xfrm>
          </p:grpSpPr>
          <p:grpSp>
            <p:nvGrpSpPr>
              <p:cNvPr id="28" name="Grupa 27"/>
              <p:cNvGrpSpPr/>
              <p:nvPr/>
            </p:nvGrpSpPr>
            <p:grpSpPr>
              <a:xfrm>
                <a:off x="383632" y="2952446"/>
                <a:ext cx="2382278" cy="2378932"/>
                <a:chOff x="387908" y="3834162"/>
                <a:chExt cx="2382278" cy="2378932"/>
              </a:xfrm>
            </p:grpSpPr>
            <p:pic>
              <p:nvPicPr>
                <p:cNvPr id="9" name="Obraz 8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55123"/>
                <a:stretch/>
              </p:blipFill>
              <p:spPr>
                <a:xfrm>
                  <a:off x="387908" y="3834162"/>
                  <a:ext cx="2382278" cy="2378932"/>
                </a:xfrm>
                <a:prstGeom prst="rect">
                  <a:avLst/>
                </a:prstGeom>
              </p:spPr>
            </p:pic>
            <p:sp>
              <p:nvSpPr>
                <p:cNvPr id="25" name="Prostokąt 24"/>
                <p:cNvSpPr/>
                <p:nvPr/>
              </p:nvSpPr>
              <p:spPr>
                <a:xfrm>
                  <a:off x="1409731" y="3888848"/>
                  <a:ext cx="380883" cy="16696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prstClr val="white"/>
                    </a:solidFill>
                  </a:endParaRPr>
                </a:p>
              </p:txBody>
            </p:sp>
          </p:grpSp>
          <p:sp>
            <p:nvSpPr>
              <p:cNvPr id="12" name="pole tekstowe 11"/>
              <p:cNvSpPr txBox="1"/>
              <p:nvPr/>
            </p:nvSpPr>
            <p:spPr>
              <a:xfrm>
                <a:off x="702072" y="3144728"/>
                <a:ext cx="24311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400" dirty="0">
                    <a:solidFill>
                      <a:prstClr val="black"/>
                    </a:solidFill>
                  </a:rPr>
                  <a:t>C</a:t>
                </a:r>
                <a:endParaRPr lang="en-US" sz="14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9" name="pole tekstowe 18"/>
              <p:cNvSpPr txBox="1"/>
              <p:nvPr/>
            </p:nvSpPr>
            <p:spPr>
              <a:xfrm>
                <a:off x="2279266" y="3203575"/>
                <a:ext cx="474810" cy="2337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19" dirty="0">
                    <a:solidFill>
                      <a:prstClr val="black"/>
                    </a:solidFill>
                  </a:rPr>
                  <a:t>ES655</a:t>
                </a:r>
                <a:endParaRPr lang="en-US" sz="919" dirty="0">
                  <a:solidFill>
                    <a:prstClr val="black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8632896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-1" y="13428"/>
            <a:ext cx="6227763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5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histograms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x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axis: linear index of fluorescence; </a:t>
            </a:r>
            <a:r>
              <a:rPr lang="en-US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axis: event count) from nuclei of single-seed samples of diploid </a:t>
            </a:r>
            <a:r>
              <a:rPr lang="en-GB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GB" sz="1200" i="1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icta</a:t>
            </a:r>
            <a:r>
              <a:rPr lang="en-GB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TM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S655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512. Each C-value (DNA content) noted for single seed was classified to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mbryo:endosper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atio and phase of cell cycle: G0/G1, G2,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reduplicatio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G2) – nuclei after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reduplicatio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Embryo -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C (G0/G1), 4C (G2), 8C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reduplicatio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G2)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sperm -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C (G0/G1), 6C (G2), 12C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reduplicatio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G2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, D Embryo -</a:t>
            </a:r>
            <a:r>
              <a:rPr lang="en-GB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C (G0/G1), 4C (G2)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sper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 6C (G0/G1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 Embryo -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C (G0/G1), 4C (G2)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sperm -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C (G0/G1), 6C (G2).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 Embryo -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C (G0/G1), 4C (G2)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sperm -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C (G0/G1), 6C (G2), 12C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reduplicatio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G2).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 Embryo -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C (G0/G1), 4C (G2), 8C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reduplicatio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G2)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sperm -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6C (G0/G1)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676738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Wykres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1079389"/>
              </p:ext>
            </p:extLst>
          </p:nvPr>
        </p:nvGraphicFramePr>
        <p:xfrm>
          <a:off x="1" y="33258"/>
          <a:ext cx="2628900" cy="27540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Wykres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7813737"/>
              </p:ext>
            </p:extLst>
          </p:nvPr>
        </p:nvGraphicFramePr>
        <p:xfrm>
          <a:off x="2575607" y="33258"/>
          <a:ext cx="3652156" cy="39569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pole tekstowe 5"/>
          <p:cNvSpPr txBox="1"/>
          <p:nvPr/>
        </p:nvSpPr>
        <p:spPr>
          <a:xfrm>
            <a:off x="1" y="3325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06212"/>
            <a:r>
              <a:rPr lang="pl-PL" sz="1400" dirty="0">
                <a:solidFill>
                  <a:prstClr val="black"/>
                </a:solidFill>
              </a:rPr>
              <a:t>A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7" name="pole tekstowe 6"/>
          <p:cNvSpPr txBox="1"/>
          <p:nvPr/>
        </p:nvSpPr>
        <p:spPr>
          <a:xfrm>
            <a:off x="2628901" y="33259"/>
            <a:ext cx="2579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06212"/>
            <a:r>
              <a:rPr lang="pl-PL" sz="1400" dirty="0">
                <a:solidFill>
                  <a:prstClr val="black"/>
                </a:solidFill>
              </a:rPr>
              <a:t>B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2" name="Prostokąt 1"/>
          <p:cNvSpPr/>
          <p:nvPr/>
        </p:nvSpPr>
        <p:spPr>
          <a:xfrm>
            <a:off x="0" y="3978601"/>
            <a:ext cx="6227761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6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mmary of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pollinate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istil development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ercentage of enlarged / degenerated pistils on day 7 after experiment started (7DAE) in ES655 (light grey) and ES512 (dark grey). n = number of pistils analysed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ercentage of the ovules on the 7 DAE containing: intact egg cell and/ or the central cell (intact egg/cc), the female gametophyte degenerated or FG during degeneration (FG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g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zygote-like or embryo-like structure (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zl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utonomous endosperm (AE). n = number of ovules analysed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19783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0" y="0"/>
            <a:ext cx="612018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2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rphology of flowers and siliques in two diploid lines of </a:t>
            </a:r>
            <a:r>
              <a:rPr lang="en-GB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GB" sz="1200" i="1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ict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LTM- left column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ES655 - middle column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ES512 – right column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lower bud stage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rphology of large/ middle-size flower bud (48-24 hour befor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hesi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48-24 HBA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rphology of middle-size/ small flower bud (72-48 HBA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-F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er at 24 HAA (hour after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hesi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-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ture seeds in 25-30-day-old siliques. The aborted (arrowheads) or underdeveloped (arrows) seeds are indicated. Images were taken under stereoscopic microscope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60350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7" y="10250"/>
            <a:ext cx="6220968" cy="64526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66829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0" y="0"/>
            <a:ext cx="6224366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3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romosome counting in original plants and F1 generation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totic prometaphase; 14 chromosomes are visible in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orophyti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of ES655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ES512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ther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-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bsequent meiotic stages in the mal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orogeni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issue of ES512; 7 chromosomes at meiotic anaphase I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metaphase II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Mitotic metaphase in cells of pistil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shoot meristem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seedling root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-K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shoot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-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meristem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F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PI staining;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eto-orcei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aining.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-M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rged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eto-orcein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aining and DIC images. Bar = 5 µm corresponds to all images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17802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467" y="21516"/>
            <a:ext cx="5614416" cy="6144768"/>
          </a:xfrm>
          <a:prstGeom prst="rect">
            <a:avLst/>
          </a:prstGeom>
        </p:spPr>
      </p:pic>
      <p:sp>
        <p:nvSpPr>
          <p:cNvPr id="3" name="Prostokąt 2"/>
          <p:cNvSpPr/>
          <p:nvPr/>
        </p:nvSpPr>
        <p:spPr>
          <a:xfrm>
            <a:off x="307467" y="6262532"/>
            <a:ext cx="561441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4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asal leaf pubescence of </a:t>
            </a:r>
            <a:r>
              <a:rPr lang="en-GB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GB" sz="1200" i="1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ict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LTM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ES655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leaves are poorly pubescent with sessile and 2-rayed (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lpighiaceou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ichom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Leaf of ES512 (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s densely covered with sessile and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lpighiaceou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ichomes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9168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09" y="13208"/>
            <a:ext cx="6181344" cy="82539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97084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rostokąt 2"/>
          <p:cNvSpPr/>
          <p:nvPr/>
        </p:nvSpPr>
        <p:spPr>
          <a:xfrm>
            <a:off x="0" y="0"/>
            <a:ext cx="6227763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5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enotypic disturbances in reproduction within ES512 accession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lenty of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pollinate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lowers (arrowheads) and very rare formed siliques (arrow)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pollinate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lower: the elongated pistil with degenerated ovules and stamens with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dehisce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ther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ilique with a few seeds and many degenerated ovule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pollinate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lower (arrowheads) and underdeveloped (small) silique (arrow); stamens with </a:t>
            </a:r>
            <a:r>
              <a:rPr lang="en-GB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dehisced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thers.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-G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Small silique with a few seeds.</a:t>
            </a:r>
            <a:endParaRPr lang="pl-P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53065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30" y="0"/>
            <a:ext cx="6182902" cy="828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2216936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2_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Pakiet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Pakiet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2201</Words>
  <Application>Microsoft Office PowerPoint</Application>
  <PresentationFormat>Niestandardowy</PresentationFormat>
  <Paragraphs>41</Paragraphs>
  <Slides>29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3</vt:i4>
      </vt:variant>
      <vt:variant>
        <vt:lpstr>Tytuły slajdów</vt:lpstr>
      </vt:variant>
      <vt:variant>
        <vt:i4>29</vt:i4>
      </vt:variant>
    </vt:vector>
  </HeadingPairs>
  <TitlesOfParts>
    <vt:vector size="36" baseType="lpstr">
      <vt:lpstr>Arial</vt:lpstr>
      <vt:lpstr>Calibri</vt:lpstr>
      <vt:lpstr>Calibri Light</vt:lpstr>
      <vt:lpstr>Times New Roman</vt:lpstr>
      <vt:lpstr>Motyw pakietu Office</vt:lpstr>
      <vt:lpstr>1_Motyw pakietu Office</vt:lpstr>
      <vt:lpstr>2_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siaR</dc:creator>
  <cp:lastModifiedBy>AsiaR</cp:lastModifiedBy>
  <cp:revision>7</cp:revision>
  <dcterms:created xsi:type="dcterms:W3CDTF">2018-05-09T04:52:31Z</dcterms:created>
  <dcterms:modified xsi:type="dcterms:W3CDTF">2018-05-09T05:52:44Z</dcterms:modified>
</cp:coreProperties>
</file>